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7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F0F5"/>
    <a:srgbClr val="28A1FC"/>
    <a:srgbClr val="0064BF"/>
    <a:srgbClr val="1848A8"/>
    <a:srgbClr val="6BBE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0ED7798-8EE8-46B9-9B30-50DDF7CA5FB7}" v="5" dt="2023-04-17T21:07:41.57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24" autoAdjust="0"/>
    <p:restoredTop sz="90068" autoAdjust="0"/>
  </p:normalViewPr>
  <p:slideViewPr>
    <p:cSldViewPr snapToGrid="0" snapToObjects="1">
      <p:cViewPr varScale="1">
        <p:scale>
          <a:sx n="55" d="100"/>
          <a:sy n="55" d="100"/>
        </p:scale>
        <p:origin x="12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ozar, Rosemary" userId="16519738-3a30-4834-984f-9b9beac7f4c0" providerId="ADAL" clId="{B9F60B81-40A2-46EE-A7FD-117E7B48E5FC}"/>
    <pc:docChg chg="modSld">
      <pc:chgData name="Kozar, Rosemary" userId="16519738-3a30-4834-984f-9b9beac7f4c0" providerId="ADAL" clId="{B9F60B81-40A2-46EE-A7FD-117E7B48E5FC}" dt="2023-04-14T21:20:01.300" v="230" actId="1076"/>
      <pc:docMkLst>
        <pc:docMk/>
      </pc:docMkLst>
      <pc:sldChg chg="addSp delSp modSp mod">
        <pc:chgData name="Kozar, Rosemary" userId="16519738-3a30-4834-984f-9b9beac7f4c0" providerId="ADAL" clId="{B9F60B81-40A2-46EE-A7FD-117E7B48E5FC}" dt="2023-04-14T21:20:01.300" v="230" actId="1076"/>
        <pc:sldMkLst>
          <pc:docMk/>
          <pc:sldMk cId="2667419773" sldId="297"/>
        </pc:sldMkLst>
        <pc:spChg chg="mod">
          <ac:chgData name="Kozar, Rosemary" userId="16519738-3a30-4834-984f-9b9beac7f4c0" providerId="ADAL" clId="{B9F60B81-40A2-46EE-A7FD-117E7B48E5FC}" dt="2023-04-14T21:15:06.974" v="4" actId="255"/>
          <ac:spMkLst>
            <pc:docMk/>
            <pc:sldMk cId="2667419773" sldId="297"/>
            <ac:spMk id="4" creationId="{00000000-0000-0000-0000-000000000000}"/>
          </ac:spMkLst>
        </pc:spChg>
        <pc:spChg chg="mod">
          <ac:chgData name="Kozar, Rosemary" userId="16519738-3a30-4834-984f-9b9beac7f4c0" providerId="ADAL" clId="{B9F60B81-40A2-46EE-A7FD-117E7B48E5FC}" dt="2023-04-14T21:19:54.246" v="229" actId="20577"/>
          <ac:spMkLst>
            <pc:docMk/>
            <pc:sldMk cId="2667419773" sldId="297"/>
            <ac:spMk id="13" creationId="{6598DCB2-880A-40C3-BDB3-03D390140AEA}"/>
          </ac:spMkLst>
        </pc:spChg>
        <pc:picChg chg="add mod">
          <ac:chgData name="Kozar, Rosemary" userId="16519738-3a30-4834-984f-9b9beac7f4c0" providerId="ADAL" clId="{B9F60B81-40A2-46EE-A7FD-117E7B48E5FC}" dt="2023-04-14T21:20:01.300" v="230" actId="1076"/>
          <ac:picMkLst>
            <pc:docMk/>
            <pc:sldMk cId="2667419773" sldId="297"/>
            <ac:picMk id="2" creationId="{B0BE6111-D540-220C-71D3-B3883AB5DCCB}"/>
          </ac:picMkLst>
        </pc:picChg>
        <pc:picChg chg="mod">
          <ac:chgData name="Kozar, Rosemary" userId="16519738-3a30-4834-984f-9b9beac7f4c0" providerId="ADAL" clId="{B9F60B81-40A2-46EE-A7FD-117E7B48E5FC}" dt="2023-04-14T21:19:26.623" v="198" actId="1076"/>
          <ac:picMkLst>
            <pc:docMk/>
            <pc:sldMk cId="2667419773" sldId="297"/>
            <ac:picMk id="7" creationId="{5D95ED5B-7DB0-3ABA-7E4A-399E8AE4BBFC}"/>
          </ac:picMkLst>
        </pc:picChg>
        <pc:picChg chg="del">
          <ac:chgData name="Kozar, Rosemary" userId="16519738-3a30-4834-984f-9b9beac7f4c0" providerId="ADAL" clId="{B9F60B81-40A2-46EE-A7FD-117E7B48E5FC}" dt="2023-04-14T21:18:23.514" v="196" actId="478"/>
          <ac:picMkLst>
            <pc:docMk/>
            <pc:sldMk cId="2667419773" sldId="297"/>
            <ac:picMk id="23" creationId="{A70A2891-1A9A-DB50-7629-C0121EC8DEED}"/>
          </ac:picMkLst>
        </pc:picChg>
      </pc:sldChg>
    </pc:docChg>
  </pc:docChgLst>
  <pc:docChgLst>
    <pc:chgData name="Kozar, Rosemary" userId="16519738-3a30-4834-984f-9b9beac7f4c0" providerId="ADAL" clId="{80ED7798-8EE8-46B9-9B30-50DDF7CA5FB7}"/>
    <pc:docChg chg="custSel modSld">
      <pc:chgData name="Kozar, Rosemary" userId="16519738-3a30-4834-984f-9b9beac7f4c0" providerId="ADAL" clId="{80ED7798-8EE8-46B9-9B30-50DDF7CA5FB7}" dt="2023-04-17T21:08:04.881" v="478" actId="20577"/>
      <pc:docMkLst>
        <pc:docMk/>
      </pc:docMkLst>
      <pc:sldChg chg="delSp modSp mod">
        <pc:chgData name="Kozar, Rosemary" userId="16519738-3a30-4834-984f-9b9beac7f4c0" providerId="ADAL" clId="{80ED7798-8EE8-46B9-9B30-50DDF7CA5FB7}" dt="2023-04-17T21:08:04.881" v="478" actId="20577"/>
        <pc:sldMkLst>
          <pc:docMk/>
          <pc:sldMk cId="2667419773" sldId="297"/>
        </pc:sldMkLst>
        <pc:spChg chg="mod">
          <ac:chgData name="Kozar, Rosemary" userId="16519738-3a30-4834-984f-9b9beac7f4c0" providerId="ADAL" clId="{80ED7798-8EE8-46B9-9B30-50DDF7CA5FB7}" dt="2023-04-17T21:08:04.881" v="478" actId="20577"/>
          <ac:spMkLst>
            <pc:docMk/>
            <pc:sldMk cId="2667419773" sldId="297"/>
            <ac:spMk id="12" creationId="{7E0409D7-99BC-45F5-92F2-AB51675346C5}"/>
          </ac:spMkLst>
        </pc:spChg>
        <pc:spChg chg="mod">
          <ac:chgData name="Kozar, Rosemary" userId="16519738-3a30-4834-984f-9b9beac7f4c0" providerId="ADAL" clId="{80ED7798-8EE8-46B9-9B30-50DDF7CA5FB7}" dt="2023-04-17T21:06:17.543" v="445" actId="20577"/>
          <ac:spMkLst>
            <pc:docMk/>
            <pc:sldMk cId="2667419773" sldId="297"/>
            <ac:spMk id="14" creationId="{DF3E3E4F-C5E3-4495-BA55-4F9EC6BB912F}"/>
          </ac:spMkLst>
        </pc:spChg>
        <pc:spChg chg="mod">
          <ac:chgData name="Kozar, Rosemary" userId="16519738-3a30-4834-984f-9b9beac7f4c0" providerId="ADAL" clId="{80ED7798-8EE8-46B9-9B30-50DDF7CA5FB7}" dt="2023-04-17T21:06:30.254" v="447" actId="1076"/>
          <ac:spMkLst>
            <pc:docMk/>
            <pc:sldMk cId="2667419773" sldId="297"/>
            <ac:spMk id="20" creationId="{DCC66A00-D1E1-F850-BC47-7096362A34F7}"/>
          </ac:spMkLst>
        </pc:spChg>
        <pc:spChg chg="mod">
          <ac:chgData name="Kozar, Rosemary" userId="16519738-3a30-4834-984f-9b9beac7f4c0" providerId="ADAL" clId="{80ED7798-8EE8-46B9-9B30-50DDF7CA5FB7}" dt="2023-04-17T21:07:01.098" v="455" actId="1076"/>
          <ac:spMkLst>
            <pc:docMk/>
            <pc:sldMk cId="2667419773" sldId="297"/>
            <ac:spMk id="25" creationId="{B56DF530-91FE-26F8-BF74-38CDB44FC14D}"/>
          </ac:spMkLst>
        </pc:spChg>
        <pc:picChg chg="mod">
          <ac:chgData name="Kozar, Rosemary" userId="16519738-3a30-4834-984f-9b9beac7f4c0" providerId="ADAL" clId="{80ED7798-8EE8-46B9-9B30-50DDF7CA5FB7}" dt="2023-04-17T21:06:36.876" v="449" actId="1076"/>
          <ac:picMkLst>
            <pc:docMk/>
            <pc:sldMk cId="2667419773" sldId="297"/>
            <ac:picMk id="9" creationId="{7E925C9F-BEAE-5F46-BDFB-B850945C5B21}"/>
          </ac:picMkLst>
        </pc:picChg>
        <pc:picChg chg="mod">
          <ac:chgData name="Kozar, Rosemary" userId="16519738-3a30-4834-984f-9b9beac7f4c0" providerId="ADAL" clId="{80ED7798-8EE8-46B9-9B30-50DDF7CA5FB7}" dt="2023-04-17T21:06:33.459" v="448" actId="1076"/>
          <ac:picMkLst>
            <pc:docMk/>
            <pc:sldMk cId="2667419773" sldId="297"/>
            <ac:picMk id="10" creationId="{8091A57C-FAC2-1301-497E-1DEAE3043346}"/>
          </ac:picMkLst>
        </pc:picChg>
        <pc:picChg chg="mod">
          <ac:chgData name="Kozar, Rosemary" userId="16519738-3a30-4834-984f-9b9beac7f4c0" providerId="ADAL" clId="{80ED7798-8EE8-46B9-9B30-50DDF7CA5FB7}" dt="2023-04-17T21:06:27.270" v="446" actId="1076"/>
          <ac:picMkLst>
            <pc:docMk/>
            <pc:sldMk cId="2667419773" sldId="297"/>
            <ac:picMk id="11" creationId="{2A61B828-87F1-8F4B-CCE9-7A5FEA14613A}"/>
          </ac:picMkLst>
        </pc:picChg>
        <pc:picChg chg="del">
          <ac:chgData name="Kozar, Rosemary" userId="16519738-3a30-4834-984f-9b9beac7f4c0" providerId="ADAL" clId="{80ED7798-8EE8-46B9-9B30-50DDF7CA5FB7}" dt="2023-04-17T21:05:41.198" v="420" actId="478"/>
          <ac:picMkLst>
            <pc:docMk/>
            <pc:sldMk cId="2667419773" sldId="297"/>
            <ac:picMk id="21" creationId="{932BA870-8134-0F2C-E438-FBD070FD0286}"/>
          </ac:picMkLst>
        </pc:picChg>
        <pc:picChg chg="mod">
          <ac:chgData name="Kozar, Rosemary" userId="16519738-3a30-4834-984f-9b9beac7f4c0" providerId="ADAL" clId="{80ED7798-8EE8-46B9-9B30-50DDF7CA5FB7}" dt="2023-04-17T21:06:58.615" v="454" actId="1076"/>
          <ac:picMkLst>
            <pc:docMk/>
            <pc:sldMk cId="2667419773" sldId="297"/>
            <ac:picMk id="22" creationId="{5E49251E-0B89-77D7-04C7-6F2F3F42C5CB}"/>
          </ac:picMkLst>
        </pc:picChg>
        <pc:picChg chg="mod">
          <ac:chgData name="Kozar, Rosemary" userId="16519738-3a30-4834-984f-9b9beac7f4c0" providerId="ADAL" clId="{80ED7798-8EE8-46B9-9B30-50DDF7CA5FB7}" dt="2023-04-17T21:07:39.248" v="459" actId="1076"/>
          <ac:picMkLst>
            <pc:docMk/>
            <pc:sldMk cId="2667419773" sldId="297"/>
            <ac:picMk id="24" creationId="{C30FC62F-54CF-683A-F111-92D8B23631FB}"/>
          </ac:picMkLst>
        </pc:picChg>
        <pc:picChg chg="mod">
          <ac:chgData name="Kozar, Rosemary" userId="16519738-3a30-4834-984f-9b9beac7f4c0" providerId="ADAL" clId="{80ED7798-8EE8-46B9-9B30-50DDF7CA5FB7}" dt="2023-04-17T21:07:41.569" v="460" actId="1076"/>
          <ac:picMkLst>
            <pc:docMk/>
            <pc:sldMk cId="2667419773" sldId="297"/>
            <ac:picMk id="26" creationId="{C01B8C45-B626-3F1D-C159-BF5351280F3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E81BC4-1899-4A12-82FE-E205F6E57443}" type="datetimeFigureOut">
              <a:rPr lang="en-AU" smtClean="0"/>
              <a:t>13/05/2023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6E4D1B-B8B4-42BE-8E27-936304CB9A1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015410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6E4D1B-B8B4-42BE-8E27-936304CB9A17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221355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8CEC-66B5-8A49-AC42-B38002A774F0}" type="datetimeFigureOut">
              <a:rPr lang="en-US" smtClean="0"/>
              <a:t>5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B2569-C1B9-504E-8638-08FA724BA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744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8CEC-66B5-8A49-AC42-B38002A774F0}" type="datetimeFigureOut">
              <a:rPr lang="en-US" smtClean="0"/>
              <a:t>5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B2569-C1B9-504E-8638-08FA724BA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928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8CEC-66B5-8A49-AC42-B38002A774F0}" type="datetimeFigureOut">
              <a:rPr lang="en-US" smtClean="0"/>
              <a:t>5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B2569-C1B9-504E-8638-08FA724BA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585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8CEC-66B5-8A49-AC42-B38002A774F0}" type="datetimeFigureOut">
              <a:rPr lang="en-US" smtClean="0"/>
              <a:t>5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B2569-C1B9-504E-8638-08FA724BA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70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8CEC-66B5-8A49-AC42-B38002A774F0}" type="datetimeFigureOut">
              <a:rPr lang="en-US" smtClean="0"/>
              <a:t>5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B2569-C1B9-504E-8638-08FA724BA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273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8CEC-66B5-8A49-AC42-B38002A774F0}" type="datetimeFigureOut">
              <a:rPr lang="en-US" smtClean="0"/>
              <a:t>5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B2569-C1B9-504E-8638-08FA724BA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907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8CEC-66B5-8A49-AC42-B38002A774F0}" type="datetimeFigureOut">
              <a:rPr lang="en-US" smtClean="0"/>
              <a:t>5/1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B2569-C1B9-504E-8638-08FA724BA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335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8CEC-66B5-8A49-AC42-B38002A774F0}" type="datetimeFigureOut">
              <a:rPr lang="en-US" smtClean="0"/>
              <a:t>5/1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B2569-C1B9-504E-8638-08FA724BA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752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8CEC-66B5-8A49-AC42-B38002A774F0}" type="datetimeFigureOut">
              <a:rPr lang="en-US" smtClean="0"/>
              <a:t>5/1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B2569-C1B9-504E-8638-08FA724BA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559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8CEC-66B5-8A49-AC42-B38002A774F0}" type="datetimeFigureOut">
              <a:rPr lang="en-US" smtClean="0"/>
              <a:t>5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B2569-C1B9-504E-8638-08FA724BA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931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38CEC-66B5-8A49-AC42-B38002A774F0}" type="datetimeFigureOut">
              <a:rPr lang="en-US" smtClean="0"/>
              <a:t>5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B2569-C1B9-504E-8638-08FA724BA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711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C38CEC-66B5-8A49-AC42-B38002A774F0}" type="datetimeFigureOut">
              <a:rPr lang="en-US" smtClean="0"/>
              <a:t>5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BB2569-C1B9-504E-8638-08FA724BA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788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5.wdp"/><Relationship Id="rId3" Type="http://schemas.openxmlformats.org/officeDocument/2006/relationships/image" Target="../media/image1.emf"/><Relationship Id="rId7" Type="http://schemas.microsoft.com/office/2007/relationships/hdphoto" Target="../media/hdphoto2.wdp"/><Relationship Id="rId12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microsoft.com/office/2007/relationships/hdphoto" Target="../media/hdphoto6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3.wdp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>
            <a:extLst>
              <a:ext uri="{FF2B5EF4-FFF2-40B4-BE49-F238E27FC236}">
                <a16:creationId xmlns:a16="http://schemas.microsoft.com/office/drawing/2014/main" id="{E4E8EA42-2AFC-1F4D-AAD6-C1E6AF70155B}"/>
              </a:ext>
            </a:extLst>
          </p:cNvPr>
          <p:cNvSpPr/>
          <p:nvPr/>
        </p:nvSpPr>
        <p:spPr>
          <a:xfrm>
            <a:off x="3936379" y="1005841"/>
            <a:ext cx="4354270" cy="4621652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CD3F694C-9EFF-4D42-90E1-21B989410462}"/>
              </a:ext>
            </a:extLst>
          </p:cNvPr>
          <p:cNvSpPr/>
          <p:nvPr/>
        </p:nvSpPr>
        <p:spPr>
          <a:xfrm>
            <a:off x="8291227" y="1005771"/>
            <a:ext cx="3901350" cy="4610836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9832DBF-F18B-B74C-B356-0B344CED5D0E}"/>
              </a:ext>
            </a:extLst>
          </p:cNvPr>
          <p:cNvSpPr/>
          <p:nvPr/>
        </p:nvSpPr>
        <p:spPr>
          <a:xfrm>
            <a:off x="-15743" y="1005771"/>
            <a:ext cx="4024800" cy="4610836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B0F0"/>
              </a:solidFill>
            </a:endParaRPr>
          </a:p>
        </p:txBody>
      </p:sp>
      <p:sp>
        <p:nvSpPr>
          <p:cNvPr id="12" name="Title 3">
            <a:extLst>
              <a:ext uri="{FF2B5EF4-FFF2-40B4-BE49-F238E27FC236}">
                <a16:creationId xmlns:a16="http://schemas.microsoft.com/office/drawing/2014/main" id="{7E0409D7-99BC-45F5-92F2-AB51675346C5}"/>
              </a:ext>
            </a:extLst>
          </p:cNvPr>
          <p:cNvSpPr txBox="1">
            <a:spLocks/>
          </p:cNvSpPr>
          <p:nvPr/>
        </p:nvSpPr>
        <p:spPr>
          <a:xfrm>
            <a:off x="8333100" y="2410190"/>
            <a:ext cx="3562505" cy="120533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endParaRPr lang="en-US" sz="3200" b="1" cap="all" dirty="0">
              <a:solidFill>
                <a:schemeClr val="bg1"/>
              </a:solidFill>
            </a:endParaRPr>
          </a:p>
          <a:p>
            <a:pPr algn="ctr"/>
            <a:endParaRPr lang="en-US" sz="3200" b="1" cap="all" dirty="0">
              <a:solidFill>
                <a:schemeClr val="bg1"/>
              </a:solidFill>
            </a:endParaRPr>
          </a:p>
          <a:p>
            <a:pPr algn="ctr"/>
            <a:r>
              <a:rPr lang="en-US" sz="3200" b="1" cap="all" dirty="0">
                <a:solidFill>
                  <a:schemeClr val="bg1"/>
                </a:solidFill>
              </a:rPr>
              <a:t>Conclusion</a:t>
            </a:r>
          </a:p>
          <a:p>
            <a:pPr algn="ctr"/>
            <a:endParaRPr lang="en-US" sz="2400" b="1" dirty="0">
              <a:solidFill>
                <a:schemeClr val="bg1"/>
              </a:solidFill>
            </a:endParaRPr>
          </a:p>
          <a:p>
            <a:pPr algn="ctr"/>
            <a:endParaRPr lang="en-US" sz="2400" b="1" dirty="0">
              <a:solidFill>
                <a:schemeClr val="bg1"/>
              </a:solidFill>
            </a:endParaRPr>
          </a:p>
          <a:p>
            <a:pPr algn="ctr"/>
            <a:endParaRPr lang="en-US" sz="2400" b="1" dirty="0">
              <a:solidFill>
                <a:schemeClr val="bg1"/>
              </a:solidFill>
            </a:endParaRPr>
          </a:p>
          <a:p>
            <a:pPr algn="ctr"/>
            <a:endParaRPr lang="en-US" sz="2400" b="1" dirty="0">
              <a:solidFill>
                <a:schemeClr val="bg1"/>
              </a:solidFill>
            </a:endParaRPr>
          </a:p>
          <a:p>
            <a:pPr algn="ctr"/>
            <a:endParaRPr lang="en-US" sz="2400" b="1" dirty="0">
              <a:solidFill>
                <a:schemeClr val="bg1"/>
              </a:solidFill>
            </a:endParaRPr>
          </a:p>
          <a:p>
            <a:pPr algn="ctr"/>
            <a:r>
              <a:rPr lang="en-US" sz="2400" b="1" dirty="0">
                <a:solidFill>
                  <a:schemeClr val="bg1"/>
                </a:solidFill>
              </a:rPr>
              <a:t>These data suggest that the use of lyophilized cryo  warrants further investigation for applicability in the military setting once available  for human use</a:t>
            </a:r>
          </a:p>
        </p:txBody>
      </p:sp>
      <p:sp>
        <p:nvSpPr>
          <p:cNvPr id="13" name="Title 3">
            <a:extLst>
              <a:ext uri="{FF2B5EF4-FFF2-40B4-BE49-F238E27FC236}">
                <a16:creationId xmlns:a16="http://schemas.microsoft.com/office/drawing/2014/main" id="{6598DCB2-880A-40C3-BDB3-03D390140AEA}"/>
              </a:ext>
            </a:extLst>
          </p:cNvPr>
          <p:cNvSpPr txBox="1">
            <a:spLocks/>
          </p:cNvSpPr>
          <p:nvPr/>
        </p:nvSpPr>
        <p:spPr>
          <a:xfrm>
            <a:off x="10082" y="1702968"/>
            <a:ext cx="4040543" cy="387195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endParaRPr lang="en-US" sz="2400" b="1" dirty="0">
              <a:solidFill>
                <a:schemeClr val="bg1"/>
              </a:solidFill>
            </a:endParaRPr>
          </a:p>
          <a:p>
            <a:pPr algn="ctr"/>
            <a:r>
              <a:rPr lang="en-US" sz="2200" b="1" dirty="0">
                <a:solidFill>
                  <a:schemeClr val="bg1"/>
                </a:solidFill>
              </a:rPr>
              <a:t>Cryoprecipitate products:  lyophilized and conventional </a:t>
            </a:r>
          </a:p>
          <a:p>
            <a:endParaRPr lang="en-US" sz="2400" b="1" dirty="0">
              <a:solidFill>
                <a:schemeClr val="bg1"/>
              </a:solidFill>
            </a:endParaRPr>
          </a:p>
          <a:p>
            <a:r>
              <a:rPr lang="en-US" sz="2000" b="1" dirty="0">
                <a:solidFill>
                  <a:schemeClr val="bg1"/>
                </a:solidFill>
              </a:rPr>
              <a:t>Methods: Mouse model of polytrauma (muscle crush and tibia </a:t>
            </a:r>
            <a:r>
              <a:rPr lang="en-US" sz="2000" b="1" dirty="0" err="1">
                <a:solidFill>
                  <a:schemeClr val="bg1"/>
                </a:solidFill>
              </a:rPr>
              <a:t>fx</a:t>
            </a:r>
            <a:r>
              <a:rPr lang="en-US" sz="2000" b="1" dirty="0">
                <a:solidFill>
                  <a:schemeClr val="bg1"/>
                </a:solidFill>
              </a:rPr>
              <a:t>) and uncontrolled hemorrhage from liver lac x 60 minutes followed by hypotensive resuscitation MAP 55-60 x 3 </a:t>
            </a:r>
            <a:r>
              <a:rPr lang="en-US" sz="2000" b="1" dirty="0" err="1">
                <a:solidFill>
                  <a:schemeClr val="bg1"/>
                </a:solidFill>
              </a:rPr>
              <a:t>hrs</a:t>
            </a:r>
            <a:endParaRPr lang="en-US" sz="2000" b="1" dirty="0">
              <a:solidFill>
                <a:schemeClr val="bg1"/>
              </a:solidFill>
            </a:endParaRPr>
          </a:p>
          <a:p>
            <a:r>
              <a:rPr lang="en-US" sz="2000" b="1" dirty="0">
                <a:solidFill>
                  <a:schemeClr val="bg1"/>
                </a:solidFill>
              </a:rPr>
              <a:t>    </a:t>
            </a:r>
          </a:p>
          <a:p>
            <a:r>
              <a:rPr lang="en-US" sz="2000" b="1" dirty="0">
                <a:solidFill>
                  <a:schemeClr val="bg1"/>
                </a:solidFill>
              </a:rPr>
              <a:t>     LR vs FFP vs cryo products</a:t>
            </a:r>
          </a:p>
          <a:p>
            <a:endParaRPr lang="en-US" sz="2400" b="1" dirty="0">
              <a:solidFill>
                <a:schemeClr val="bg1"/>
              </a:solidFill>
            </a:endParaRPr>
          </a:p>
          <a:p>
            <a:endParaRPr lang="en-US" sz="2400" b="1" dirty="0">
              <a:solidFill>
                <a:schemeClr val="bg1"/>
              </a:solidFill>
            </a:endParaRPr>
          </a:p>
          <a:p>
            <a:pPr algn="ctr"/>
            <a:endParaRPr lang="en-US" sz="2400" b="1" dirty="0">
              <a:solidFill>
                <a:schemeClr val="bg1"/>
              </a:solidFill>
            </a:endParaRPr>
          </a:p>
          <a:p>
            <a:pPr algn="ctr"/>
            <a:r>
              <a:rPr lang="en-US" sz="2000" b="1" dirty="0">
                <a:solidFill>
                  <a:schemeClr val="bg1"/>
                </a:solidFill>
              </a:rPr>
              <a:t>Blood and  lungs harvested </a:t>
            </a:r>
          </a:p>
          <a:p>
            <a:pPr algn="ctr"/>
            <a:r>
              <a:rPr lang="en-US" sz="2000" b="1" dirty="0">
                <a:solidFill>
                  <a:schemeClr val="bg1"/>
                </a:solidFill>
              </a:rPr>
              <a:t>after 3 hours</a:t>
            </a:r>
          </a:p>
          <a:p>
            <a:pPr algn="ctr"/>
            <a:endParaRPr lang="en-US" sz="2400" b="1" dirty="0">
              <a:solidFill>
                <a:schemeClr val="bg1"/>
              </a:solidFill>
            </a:endParaRPr>
          </a:p>
          <a:p>
            <a:pPr algn="ctr"/>
            <a:endParaRPr lang="en-US" sz="2400" b="1" dirty="0">
              <a:solidFill>
                <a:schemeClr val="bg1"/>
              </a:solidFill>
            </a:endParaRPr>
          </a:p>
          <a:p>
            <a:pPr algn="ctr"/>
            <a:r>
              <a:rPr lang="en-US" sz="2400" b="1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14" name="Title 3">
            <a:extLst>
              <a:ext uri="{FF2B5EF4-FFF2-40B4-BE49-F238E27FC236}">
                <a16:creationId xmlns:a16="http://schemas.microsoft.com/office/drawing/2014/main" id="{DF3E3E4F-C5E3-4495-BA55-4F9EC6BB912F}"/>
              </a:ext>
            </a:extLst>
          </p:cNvPr>
          <p:cNvSpPr txBox="1">
            <a:spLocks/>
          </p:cNvSpPr>
          <p:nvPr/>
        </p:nvSpPr>
        <p:spPr>
          <a:xfrm>
            <a:off x="4040044" y="1135892"/>
            <a:ext cx="4262069" cy="201352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endParaRPr lang="en-US" sz="3200" b="1" dirty="0">
              <a:solidFill>
                <a:schemeClr val="bg1"/>
              </a:solidFill>
            </a:endParaRPr>
          </a:p>
          <a:p>
            <a:pPr algn="ctr"/>
            <a:endParaRPr lang="en-US" sz="3200" b="1" dirty="0">
              <a:solidFill>
                <a:schemeClr val="bg1"/>
              </a:solidFill>
            </a:endParaRPr>
          </a:p>
          <a:p>
            <a:pPr algn="ctr"/>
            <a:endParaRPr lang="en-US" sz="3200" b="1" dirty="0">
              <a:solidFill>
                <a:schemeClr val="bg1"/>
              </a:solidFill>
            </a:endParaRPr>
          </a:p>
          <a:p>
            <a:pPr algn="ctr"/>
            <a:endParaRPr lang="en-US" sz="3200" b="1" dirty="0">
              <a:solidFill>
                <a:schemeClr val="bg1"/>
              </a:solidFill>
            </a:endParaRPr>
          </a:p>
          <a:p>
            <a:pPr algn="ctr"/>
            <a:r>
              <a:rPr lang="en-US" sz="3200" b="1" dirty="0">
                <a:solidFill>
                  <a:schemeClr val="bg1"/>
                </a:solidFill>
              </a:rPr>
              <a:t>RESULTS</a:t>
            </a:r>
          </a:p>
          <a:p>
            <a:pPr algn="ctr"/>
            <a:endParaRPr lang="en-US" sz="3200" b="1" dirty="0">
              <a:solidFill>
                <a:schemeClr val="bg1"/>
              </a:solidFill>
            </a:endParaRPr>
          </a:p>
          <a:p>
            <a:endParaRPr lang="en-US" sz="2200" b="1" dirty="0">
              <a:solidFill>
                <a:schemeClr val="bg1"/>
              </a:solidFill>
            </a:endParaRPr>
          </a:p>
          <a:p>
            <a:endParaRPr lang="en-US" sz="2200" b="1" dirty="0">
              <a:solidFill>
                <a:schemeClr val="bg1"/>
              </a:solidFill>
            </a:endParaRPr>
          </a:p>
          <a:p>
            <a:endParaRPr lang="en-US" sz="2200" b="1" dirty="0">
              <a:solidFill>
                <a:schemeClr val="bg1"/>
              </a:solidFill>
            </a:endParaRPr>
          </a:p>
          <a:p>
            <a:endParaRPr lang="en-US" sz="2200" b="1" dirty="0">
              <a:solidFill>
                <a:schemeClr val="bg1"/>
              </a:solidFill>
            </a:endParaRPr>
          </a:p>
          <a:p>
            <a:pPr algn="ctr"/>
            <a:r>
              <a:rPr lang="en-US" sz="2800" b="1" dirty="0">
                <a:solidFill>
                  <a:schemeClr val="bg1"/>
                </a:solidFill>
              </a:rPr>
              <a:t>Cryo products and FFP reduced the endotheliopathy of trauma with additional benefit from lyophilized cryo by  enhancing ADAMTS13:VWF ratio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1808D77C-4417-0241-9B4C-CE7951E15E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80786" y="5757545"/>
            <a:ext cx="3482129" cy="1028811"/>
          </a:xfrm>
          <a:prstGeom prst="rect">
            <a:avLst/>
          </a:prstGeom>
        </p:spPr>
      </p:pic>
      <p:sp>
        <p:nvSpPr>
          <p:cNvPr id="16" name="Title 3">
            <a:extLst>
              <a:ext uri="{FF2B5EF4-FFF2-40B4-BE49-F238E27FC236}">
                <a16:creationId xmlns:a16="http://schemas.microsoft.com/office/drawing/2014/main" id="{B6AB36D4-ED69-6F49-A150-A21AA8A989DE}"/>
              </a:ext>
            </a:extLst>
          </p:cNvPr>
          <p:cNvSpPr txBox="1">
            <a:spLocks/>
          </p:cNvSpPr>
          <p:nvPr/>
        </p:nvSpPr>
        <p:spPr>
          <a:xfrm>
            <a:off x="-361561" y="6484776"/>
            <a:ext cx="8827136" cy="31503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250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0" b="1" dirty="0"/>
              <a:t>        @JTraumAcuteSurg                                    </a:t>
            </a:r>
            <a:r>
              <a:rPr lang="en-US" dirty="0"/>
              <a:t>Copyright © 2023  Wolters Kluwer Health, Inc. All rights reserved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DDC5C5A-A842-ECA9-9040-6B5B8988C7F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2823" b="79839" l="9709" r="89806">
                        <a14:foregroundMark x1="73786" y1="8065" x2="23786" y2="10081"/>
                        <a14:foregroundMark x1="48544" y1="2823" x2="48544" y2="10081"/>
                        <a14:foregroundMark x1="35922" y1="20161" x2="59223" y2="16129"/>
                        <a14:foregroundMark x1="59223" y1="45968" x2="39320" y2="47581"/>
                      </a14:backgroundRemoval>
                    </a14:imgEffect>
                  </a14:imgLayer>
                </a14:imgProps>
              </a:ext>
            </a:extLst>
          </a:blip>
          <a:srcRect b="11121"/>
          <a:stretch/>
        </p:blipFill>
        <p:spPr>
          <a:xfrm>
            <a:off x="686695" y="4123628"/>
            <a:ext cx="731251" cy="93414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5D70C96-A55C-A88A-78F7-17A3355BDA1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1961" b="98693" l="3158" r="94737">
                        <a14:foregroundMark x1="4211" y1="5882" x2="27368" y2="6536"/>
                        <a14:foregroundMark x1="41583" y1="4575" x2="46316" y2="3922"/>
                        <a14:foregroundMark x1="27368" y1="6536" x2="41583" y2="4575"/>
                        <a14:foregroundMark x1="50312" y1="4575" x2="66316" y2="7190"/>
                        <a14:foregroundMark x1="46316" y1="3922" x2="50312" y2="4575"/>
                        <a14:foregroundMark x1="66316" y1="7190" x2="81042" y2="7190"/>
                        <a14:foregroundMark x1="51579" y1="6536" x2="46316" y2="11765"/>
                        <a14:foregroundMark x1="50106" y1="4575" x2="52632" y2="5882"/>
                        <a14:foregroundMark x1="48844" y1="3922" x2="50106" y2="4575"/>
                        <a14:foregroundMark x1="46316" y1="2614" x2="48844" y2="3922"/>
                        <a14:foregroundMark x1="88421" y1="5882" x2="89523" y2="7079"/>
                        <a14:foregroundMark x1="92679" y1="76422" x2="92632" y2="77124"/>
                        <a14:foregroundMark x1="92632" y1="77124" x2="85416" y2="85586"/>
                        <a14:foregroundMark x1="10664" y1="86077" x2="9474" y2="85621"/>
                        <a14:foregroundMark x1="9342" y1="84967" x2="4359" y2="60216"/>
                        <a14:foregroundMark x1="9474" y1="85621" x2="9342" y2="84967"/>
                        <a14:foregroundMark x1="4321" y1="42484" x2="6316" y2="36601"/>
                        <a14:foregroundMark x1="3916" y1="43680" x2="4321" y2="42484"/>
                        <a14:foregroundMark x1="6316" y1="36601" x2="4211" y2="11111"/>
                        <a14:foregroundMark x1="4211" y1="11111" x2="8421" y2="5229"/>
                        <a14:foregroundMark x1="37001" y1="89829" x2="40155" y2="89969"/>
                        <a14:foregroundMark x1="70633" y1="96012" x2="70768" y2="95928"/>
                        <a14:foregroundMark x1="86316" y1="6536" x2="86316" y2="6536"/>
                        <a14:foregroundMark x1="87368" y1="5882" x2="87368" y2="5882"/>
                        <a14:foregroundMark x1="86316" y1="5882" x2="86316" y2="5882"/>
                        <a14:foregroundMark x1="86316" y1="5882" x2="86316" y2="5882"/>
                        <a14:foregroundMark x1="89474" y1="5882" x2="82105" y2="5882"/>
                        <a14:foregroundMark x1="93684" y1="9804" x2="90526" y2="60131"/>
                        <a14:foregroundMark x1="93684" y1="54902" x2="93684" y2="74510"/>
                        <a14:foregroundMark x1="30526" y1="91503" x2="30526" y2="91503"/>
                        <a14:foregroundMark x1="41053" y1="96732" x2="41053" y2="96732"/>
                        <a14:foregroundMark x1="69474" y1="90196" x2="69474" y2="90196"/>
                        <a14:foregroundMark x1="57895" y1="92157" x2="57895" y2="92157"/>
                        <a14:foregroundMark x1="52632" y1="96732" x2="52632" y2="96732"/>
                        <a14:foregroundMark x1="4484" y1="54156" x2="5263" y2="59477"/>
                        <a14:foregroundMark x1="4211" y1="54167" x2="4211" y2="58170"/>
                        <a14:foregroundMark x1="7140" y1="54053" x2="7368" y2="54902"/>
                        <a14:foregroundMark x1="4211" y1="43137" x2="4352" y2="43663"/>
                        <a14:foregroundMark x1="4211" y1="58824" x2="5263" y2="61438"/>
                        <a14:foregroundMark x1="49474" y1="94118" x2="49474" y2="94118"/>
                        <a14:foregroundMark x1="85263" y1="6536" x2="85263" y2="6536"/>
                        <a14:foregroundMark x1="85263" y1="6536" x2="85263" y2="6536"/>
                        <a14:foregroundMark x1="83158" y1="5882" x2="83158" y2="5882"/>
                        <a14:foregroundMark x1="85263" y1="5882" x2="85263" y2="5882"/>
                        <a14:foregroundMark x1="86316" y1="5882" x2="84211" y2="6536"/>
                        <a14:foregroundMark x1="5263" y1="44444" x2="5263" y2="50980"/>
                        <a14:foregroundMark x1="5263" y1="43791" x2="5263" y2="43791"/>
                        <a14:foregroundMark x1="4211" y1="43137" x2="4211" y2="43137"/>
                        <a14:foregroundMark x1="4211" y1="43791" x2="4211" y2="43791"/>
                        <a14:foregroundMark x1="4211" y1="41830" x2="5263" y2="45752"/>
                        <a14:foregroundMark x1="4211" y1="50980" x2="4211" y2="52288"/>
                        <a14:foregroundMark x1="4211" y1="52941" x2="4211" y2="54248"/>
                        <a14:foregroundMark x1="5263" y1="52941" x2="5263" y2="51634"/>
                        <a14:foregroundMark x1="4211" y1="52288" x2="4211" y2="53595"/>
                        <a14:backgroundMark x1="44211" y1="4575" x2="44211" y2="4575"/>
                        <a14:backgroundMark x1="40000" y1="4575" x2="40000" y2="4575"/>
                        <a14:backgroundMark x1="37895" y1="3922" x2="37895" y2="3922"/>
                        <a14:backgroundMark x1="36842" y1="4575" x2="36842" y2="4575"/>
                        <a14:backgroundMark x1="34737" y1="4575" x2="34737" y2="4575"/>
                        <a14:backgroundMark x1="33684" y1="4575" x2="33684" y2="4575"/>
                        <a14:backgroundMark x1="41053" y1="4575" x2="41053" y2="4575"/>
                        <a14:backgroundMark x1="44211" y1="1961" x2="44211" y2="1961"/>
                        <a14:backgroundMark x1="53684" y1="3922" x2="53684" y2="3922"/>
                        <a14:backgroundMark x1="55789" y1="4575" x2="55789" y2="4575"/>
                        <a14:backgroundMark x1="57895" y1="4575" x2="57895" y2="4575"/>
                        <a14:backgroundMark x1="90526" y1="4575" x2="90526" y2="4575"/>
                        <a14:backgroundMark x1="96902" y1="74510" x2="96842" y2="76471"/>
                        <a14:backgroundMark x1="98947" y1="7190" x2="98864" y2="9929"/>
                        <a14:backgroundMark x1="86316" y1="4575" x2="86316" y2="4575"/>
                        <a14:backgroundMark x1="8421" y1="4575" x2="8421" y2="4575"/>
                        <a14:backgroundMark x1="6316" y1="4575" x2="6316" y2="4575"/>
                        <a14:backgroundMark x1="5263" y1="4575" x2="5263" y2="4575"/>
                        <a14:backgroundMark x1="10526" y1="3922" x2="10526" y2="3922"/>
                        <a14:backgroundMark x1="3158" y1="5229" x2="3158" y2="5229"/>
                        <a14:backgroundMark x1="13578" y1="91503" x2="15789" y2="93464"/>
                        <a14:backgroundMark x1="8421" y1="86928" x2="13578" y2="91503"/>
                        <a14:backgroundMark x1="20000" y1="94118" x2="20000" y2="94118"/>
                        <a14:backgroundMark x1="20000" y1="91503" x2="22105" y2="94118"/>
                        <a14:backgroundMark x1="10526" y1="86275" x2="10526" y2="86275"/>
                        <a14:backgroundMark x1="7368" y1="84967" x2="7368" y2="84967"/>
                        <a14:backgroundMark x1="8421" y1="84967" x2="8421" y2="84967"/>
                        <a14:backgroundMark x1="11579" y1="86928" x2="11579" y2="86928"/>
                        <a14:backgroundMark x1="24211" y1="92810" x2="24211" y2="92810"/>
                        <a14:backgroundMark x1="25263" y1="94771" x2="25263" y2="94771"/>
                        <a14:backgroundMark x1="81404" y1="90196" x2="72632" y2="96732"/>
                        <a14:backgroundMark x1="83158" y1="88889" x2="81404" y2="90196"/>
                        <a14:backgroundMark x1="85263" y1="88235" x2="85263" y2="88235"/>
                        <a14:backgroundMark x1="87368" y1="86928" x2="81053" y2="88889"/>
                        <a14:backgroundMark x1="72632" y1="97386" x2="66316" y2="99346"/>
                        <a14:backgroundMark x1="72632" y1="96732" x2="72632" y2="96732"/>
                        <a14:backgroundMark x1="71579" y1="96732" x2="71579" y2="96732"/>
                        <a14:backgroundMark x1="73684" y1="94771" x2="73684" y2="94771"/>
                        <a14:backgroundMark x1="66316" y1="99346" x2="29474" y2="99346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614186" y="4147460"/>
            <a:ext cx="464438" cy="747989"/>
          </a:xfrm>
          <a:prstGeom prst="rect">
            <a:avLst/>
          </a:prstGeom>
        </p:spPr>
      </p:pic>
      <p:pic>
        <p:nvPicPr>
          <p:cNvPr id="7" name="Picture 6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5D95ED5B-7DB0-3ABA-7E4A-399E8AE4BBF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ackgroundRemoval t="9375" b="91667" l="7879" r="92121">
                        <a14:foregroundMark x1="72121" y1="19792" x2="72121" y2="19792"/>
                        <a14:foregroundMark x1="83636" y1="13542" x2="83636" y2="13542"/>
                        <a14:foregroundMark x1="90303" y1="13542" x2="90303" y2="13542"/>
                        <a14:foregroundMark x1="93333" y1="12500" x2="93333" y2="12500"/>
                        <a14:foregroundMark x1="46061" y1="91667" x2="46061" y2="91667"/>
                        <a14:foregroundMark x1="7879" y1="67708" x2="7879" y2="67708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8824"/>
          <a:stretch/>
        </p:blipFill>
        <p:spPr>
          <a:xfrm>
            <a:off x="2833008" y="1428624"/>
            <a:ext cx="1091907" cy="89256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6106699-A80C-BD8C-977C-7C4A2F42BA6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ackgroundRemoval t="6618" b="96324" l="8081" r="89899">
                        <a14:foregroundMark x1="11111" y1="13235" x2="58586" y2="11765"/>
                        <a14:foregroundMark x1="58586" y1="11765" x2="81818" y2="13235"/>
                        <a14:foregroundMark x1="89723" y1="46324" x2="89899" y2="47059"/>
                        <a14:foregroundMark x1="81818" y1="13235" x2="89723" y2="46324"/>
                        <a14:foregroundMark x1="89731" y1="50000" x2="87879" y2="82353"/>
                        <a14:foregroundMark x1="89857" y1="47794" x2="89731" y2="50000"/>
                        <a14:foregroundMark x1="89899" y1="47059" x2="89857" y2="47794"/>
                        <a14:foregroundMark x1="87879" y1="82353" x2="69697" y2="93382"/>
                        <a14:foregroundMark x1="69697" y1="93382" x2="58944" y2="94403"/>
                        <a14:foregroundMark x1="25890" y1="88665" x2="30303" y2="66176"/>
                        <a14:foregroundMark x1="30303" y1="66176" x2="23232" y2="83824"/>
                        <a14:foregroundMark x1="23232" y1="83824" x2="11111" y2="69118"/>
                        <a14:foregroundMark x1="11111" y1="69118" x2="9326" y2="37500"/>
                        <a14:foregroundMark x1="10101" y1="14706" x2="16162" y2="12500"/>
                        <a14:foregroundMark x1="81818" y1="12500" x2="87879" y2="19118"/>
                        <a14:foregroundMark x1="70707" y1="91912" x2="58911" y2="94366"/>
                        <a14:foregroundMark x1="58952" y1="94412" x2="67677" y2="92647"/>
                        <a14:foregroundMark x1="78399" y1="50000" x2="79798" y2="56618"/>
                        <a14:foregroundMark x1="77933" y1="47794" x2="78399" y2="50000"/>
                        <a14:foregroundMark x1="77622" y1="46324" x2="77933" y2="47794"/>
                        <a14:foregroundMark x1="75758" y1="37500" x2="77622" y2="46324"/>
                        <a14:foregroundMark x1="79798" y1="56618" x2="57576" y2="68382"/>
                        <a14:foregroundMark x1="57576" y1="68382" x2="28283" y2="72059"/>
                        <a14:foregroundMark x1="28283" y1="72059" x2="22222" y2="54412"/>
                        <a14:foregroundMark x1="22222" y1="54412" x2="43434" y2="38235"/>
                        <a14:foregroundMark x1="43434" y1="38235" x2="71717" y2="50000"/>
                        <a14:foregroundMark x1="71717" y1="50000" x2="41414" y2="55147"/>
                        <a14:foregroundMark x1="41414" y1="55147" x2="23232" y2="44118"/>
                        <a14:foregroundMark x1="23232" y1="44118" x2="72727" y2="46324"/>
                        <a14:foregroundMark x1="72727" y1="46324" x2="72727" y2="47059"/>
                        <a14:foregroundMark x1="64646" y1="58824" x2="40404" y2="61029"/>
                        <a14:foregroundMark x1="40404" y1="61029" x2="63636" y2="58088"/>
                        <a14:foregroundMark x1="63636" y1="58088" x2="59596" y2="56618"/>
                        <a14:foregroundMark x1="56566" y1="53676" x2="26263" y2="55882"/>
                        <a14:foregroundMark x1="26263" y1="55882" x2="55556" y2="54412"/>
                        <a14:foregroundMark x1="55556" y1="54412" x2="76768" y2="55147"/>
                        <a14:foregroundMark x1="11111" y1="16912" x2="11111" y2="38971"/>
                        <a14:foregroundMark x1="86869" y1="20588" x2="86869" y2="42647"/>
                        <a14:foregroundMark x1="88889" y1="20588" x2="88889" y2="42647"/>
                        <a14:foregroundMark x1="88889" y1="47794" x2="88889" y2="49265"/>
                        <a14:foregroundMark x1="88889" y1="46324" x2="88889" y2="47794"/>
                        <a14:foregroundMark x1="10101" y1="19118" x2="9091" y2="15441"/>
                        <a14:foregroundMark x1="9091" y1="13971" x2="9091" y2="21324"/>
                        <a14:foregroundMark x1="67677" y1="11765" x2="58586" y2="12500"/>
                        <a14:foregroundMark x1="63636" y1="11765" x2="58586" y2="12500"/>
                        <a14:foregroundMark x1="65657" y1="11029" x2="59596" y2="11765"/>
                        <a14:foregroundMark x1="46465" y1="11029" x2="50505" y2="10294"/>
                        <a14:foregroundMark x1="49495" y1="6618" x2="49495" y2="6618"/>
                        <a14:backgroundMark x1="93939" y1="50000" x2="93939" y2="50000"/>
                        <a14:backgroundMark x1="71717" y1="98529" x2="71717" y2="98529"/>
                        <a14:backgroundMark x1="68687" y1="98529" x2="68687" y2="98529"/>
                        <a14:backgroundMark x1="66667" y1="97059" x2="66667" y2="97059"/>
                        <a14:backgroundMark x1="64646" y1="97059" x2="64646" y2="97059"/>
                        <a14:backgroundMark x1="62626" y1="98529" x2="30303" y2="99265"/>
                        <a14:backgroundMark x1="30303" y1="99265" x2="25253" y2="95588"/>
                        <a14:backgroundMark x1="92929" y1="47794" x2="92929" y2="47794"/>
                        <a14:backgroundMark x1="90909" y1="82353" x2="90909" y2="82353"/>
                        <a14:backgroundMark x1="67677" y1="8824" x2="67677" y2="8824"/>
                        <a14:backgroundMark x1="66667" y1="8824" x2="66667" y2="8824"/>
                        <a14:backgroundMark x1="65657" y1="8824" x2="65657" y2="8824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76344" y="4090968"/>
            <a:ext cx="568552" cy="85322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E925C9F-BEAE-5F46-BDFB-B850945C5B21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ackgroundRemoval t="6618" b="96324" l="8081" r="89899">
                        <a14:foregroundMark x1="11111" y1="13235" x2="58586" y2="11765"/>
                        <a14:foregroundMark x1="58586" y1="11765" x2="81818" y2="13235"/>
                        <a14:foregroundMark x1="89723" y1="46324" x2="89899" y2="47059"/>
                        <a14:foregroundMark x1="81818" y1="13235" x2="89723" y2="46324"/>
                        <a14:foregroundMark x1="89731" y1="50000" x2="87879" y2="82353"/>
                        <a14:foregroundMark x1="89857" y1="47794" x2="89731" y2="50000"/>
                        <a14:foregroundMark x1="89899" y1="47059" x2="89857" y2="47794"/>
                        <a14:foregroundMark x1="87879" y1="82353" x2="69697" y2="93382"/>
                        <a14:foregroundMark x1="69697" y1="93382" x2="58944" y2="94403"/>
                        <a14:foregroundMark x1="25890" y1="88665" x2="30303" y2="66176"/>
                        <a14:foregroundMark x1="30303" y1="66176" x2="23232" y2="83824"/>
                        <a14:foregroundMark x1="23232" y1="83824" x2="11111" y2="69118"/>
                        <a14:foregroundMark x1="11111" y1="69118" x2="9326" y2="37500"/>
                        <a14:foregroundMark x1="10101" y1="14706" x2="16162" y2="12500"/>
                        <a14:foregroundMark x1="81818" y1="12500" x2="87879" y2="19118"/>
                        <a14:foregroundMark x1="70707" y1="91912" x2="58911" y2="94366"/>
                        <a14:foregroundMark x1="58952" y1="94412" x2="67677" y2="92647"/>
                        <a14:foregroundMark x1="78399" y1="50000" x2="79798" y2="56618"/>
                        <a14:foregroundMark x1="77933" y1="47794" x2="78399" y2="50000"/>
                        <a14:foregroundMark x1="77622" y1="46324" x2="77933" y2="47794"/>
                        <a14:foregroundMark x1="75758" y1="37500" x2="77622" y2="46324"/>
                        <a14:foregroundMark x1="79798" y1="56618" x2="57576" y2="68382"/>
                        <a14:foregroundMark x1="57576" y1="68382" x2="28283" y2="72059"/>
                        <a14:foregroundMark x1="28283" y1="72059" x2="22222" y2="54412"/>
                        <a14:foregroundMark x1="22222" y1="54412" x2="43434" y2="38235"/>
                        <a14:foregroundMark x1="43434" y1="38235" x2="71717" y2="50000"/>
                        <a14:foregroundMark x1="71717" y1="50000" x2="41414" y2="55147"/>
                        <a14:foregroundMark x1="41414" y1="55147" x2="23232" y2="44118"/>
                        <a14:foregroundMark x1="23232" y1="44118" x2="72727" y2="46324"/>
                        <a14:foregroundMark x1="72727" y1="46324" x2="72727" y2="47059"/>
                        <a14:foregroundMark x1="64646" y1="58824" x2="40404" y2="61029"/>
                        <a14:foregroundMark x1="40404" y1="61029" x2="63636" y2="58088"/>
                        <a14:foregroundMark x1="63636" y1="58088" x2="59596" y2="56618"/>
                        <a14:foregroundMark x1="56566" y1="53676" x2="26263" y2="55882"/>
                        <a14:foregroundMark x1="26263" y1="55882" x2="55556" y2="54412"/>
                        <a14:foregroundMark x1="55556" y1="54412" x2="76768" y2="55147"/>
                        <a14:foregroundMark x1="11111" y1="16912" x2="11111" y2="38971"/>
                        <a14:foregroundMark x1="86869" y1="20588" x2="86869" y2="42647"/>
                        <a14:foregroundMark x1="88889" y1="20588" x2="88889" y2="42647"/>
                        <a14:foregroundMark x1="88889" y1="47794" x2="88889" y2="49265"/>
                        <a14:foregroundMark x1="88889" y1="46324" x2="88889" y2="47794"/>
                        <a14:foregroundMark x1="10101" y1="19118" x2="9091" y2="15441"/>
                        <a14:foregroundMark x1="9091" y1="13971" x2="9091" y2="21324"/>
                        <a14:foregroundMark x1="67677" y1="11765" x2="58586" y2="12500"/>
                        <a14:foregroundMark x1="63636" y1="11765" x2="58586" y2="12500"/>
                        <a14:foregroundMark x1="65657" y1="11029" x2="59596" y2="11765"/>
                        <a14:foregroundMark x1="46465" y1="11029" x2="50505" y2="10294"/>
                        <a14:foregroundMark x1="49495" y1="6618" x2="49495" y2="6618"/>
                        <a14:backgroundMark x1="93939" y1="50000" x2="93939" y2="50000"/>
                        <a14:backgroundMark x1="71717" y1="98529" x2="71717" y2="98529"/>
                        <a14:backgroundMark x1="68687" y1="98529" x2="68687" y2="98529"/>
                        <a14:backgroundMark x1="66667" y1="97059" x2="66667" y2="97059"/>
                        <a14:backgroundMark x1="64646" y1="97059" x2="64646" y2="97059"/>
                        <a14:backgroundMark x1="62626" y1="98529" x2="30303" y2="99265"/>
                        <a14:backgroundMark x1="30303" y1="99265" x2="25253" y2="95588"/>
                        <a14:backgroundMark x1="92929" y1="47794" x2="92929" y2="47794"/>
                        <a14:backgroundMark x1="90909" y1="82353" x2="90909" y2="82353"/>
                        <a14:backgroundMark x1="67677" y1="8824" x2="67677" y2="8824"/>
                        <a14:backgroundMark x1="66667" y1="8824" x2="66667" y2="8824"/>
                        <a14:backgroundMark x1="65657" y1="8824" x2="65657" y2="8824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65906" y="1218530"/>
            <a:ext cx="912092" cy="136877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091A57C-FAC2-1301-497E-1DEAE304334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1961" b="98693" l="3158" r="94737">
                        <a14:foregroundMark x1="4211" y1="5882" x2="27368" y2="6536"/>
                        <a14:foregroundMark x1="41583" y1="4575" x2="46316" y2="3922"/>
                        <a14:foregroundMark x1="27368" y1="6536" x2="41583" y2="4575"/>
                        <a14:foregroundMark x1="50312" y1="4575" x2="66316" y2="7190"/>
                        <a14:foregroundMark x1="46316" y1="3922" x2="50312" y2="4575"/>
                        <a14:foregroundMark x1="66316" y1="7190" x2="81042" y2="7190"/>
                        <a14:foregroundMark x1="51579" y1="6536" x2="46316" y2="11765"/>
                        <a14:foregroundMark x1="50106" y1="4575" x2="52632" y2="5882"/>
                        <a14:foregroundMark x1="48844" y1="3922" x2="50106" y2="4575"/>
                        <a14:foregroundMark x1="46316" y1="2614" x2="48844" y2="3922"/>
                        <a14:foregroundMark x1="88421" y1="5882" x2="89523" y2="7079"/>
                        <a14:foregroundMark x1="92679" y1="76422" x2="92632" y2="77124"/>
                        <a14:foregroundMark x1="92632" y1="77124" x2="85416" y2="85586"/>
                        <a14:foregroundMark x1="10664" y1="86077" x2="9474" y2="85621"/>
                        <a14:foregroundMark x1="9342" y1="84967" x2="4359" y2="60216"/>
                        <a14:foregroundMark x1="9474" y1="85621" x2="9342" y2="84967"/>
                        <a14:foregroundMark x1="4321" y1="42484" x2="6316" y2="36601"/>
                        <a14:foregroundMark x1="3916" y1="43680" x2="4321" y2="42484"/>
                        <a14:foregroundMark x1="6316" y1="36601" x2="4211" y2="11111"/>
                        <a14:foregroundMark x1="4211" y1="11111" x2="8421" y2="5229"/>
                        <a14:foregroundMark x1="37001" y1="89829" x2="40155" y2="89969"/>
                        <a14:foregroundMark x1="70633" y1="96012" x2="70768" y2="95928"/>
                        <a14:foregroundMark x1="86316" y1="6536" x2="86316" y2="6536"/>
                        <a14:foregroundMark x1="87368" y1="5882" x2="87368" y2="5882"/>
                        <a14:foregroundMark x1="86316" y1="5882" x2="86316" y2="5882"/>
                        <a14:foregroundMark x1="86316" y1="5882" x2="86316" y2="5882"/>
                        <a14:foregroundMark x1="89474" y1="5882" x2="82105" y2="5882"/>
                        <a14:foregroundMark x1="93684" y1="9804" x2="90526" y2="60131"/>
                        <a14:foregroundMark x1="93684" y1="54902" x2="93684" y2="74510"/>
                        <a14:foregroundMark x1="30526" y1="91503" x2="30526" y2="91503"/>
                        <a14:foregroundMark x1="41053" y1="96732" x2="41053" y2="96732"/>
                        <a14:foregroundMark x1="69474" y1="90196" x2="69474" y2="90196"/>
                        <a14:foregroundMark x1="57895" y1="92157" x2="57895" y2="92157"/>
                        <a14:foregroundMark x1="52632" y1="96732" x2="52632" y2="96732"/>
                        <a14:foregroundMark x1="4484" y1="54156" x2="5263" y2="59477"/>
                        <a14:foregroundMark x1="4211" y1="54167" x2="4211" y2="58170"/>
                        <a14:foregroundMark x1="7140" y1="54053" x2="7368" y2="54902"/>
                        <a14:foregroundMark x1="4211" y1="43137" x2="4352" y2="43663"/>
                        <a14:foregroundMark x1="4211" y1="58824" x2="5263" y2="61438"/>
                        <a14:foregroundMark x1="49474" y1="94118" x2="49474" y2="94118"/>
                        <a14:foregroundMark x1="85263" y1="6536" x2="85263" y2="6536"/>
                        <a14:foregroundMark x1="85263" y1="6536" x2="85263" y2="6536"/>
                        <a14:foregroundMark x1="83158" y1="5882" x2="83158" y2="5882"/>
                        <a14:foregroundMark x1="85263" y1="5882" x2="85263" y2="5882"/>
                        <a14:foregroundMark x1="86316" y1="5882" x2="84211" y2="6536"/>
                        <a14:foregroundMark x1="5263" y1="44444" x2="5263" y2="50980"/>
                        <a14:foregroundMark x1="5263" y1="43791" x2="5263" y2="43791"/>
                        <a14:foregroundMark x1="4211" y1="43137" x2="4211" y2="43137"/>
                        <a14:foregroundMark x1="4211" y1="43791" x2="4211" y2="43791"/>
                        <a14:foregroundMark x1="4211" y1="41830" x2="5263" y2="45752"/>
                        <a14:foregroundMark x1="4211" y1="50980" x2="4211" y2="52288"/>
                        <a14:foregroundMark x1="4211" y1="52941" x2="4211" y2="54248"/>
                        <a14:foregroundMark x1="5263" y1="52941" x2="5263" y2="51634"/>
                        <a14:foregroundMark x1="4211" y1="52288" x2="4211" y2="53595"/>
                        <a14:backgroundMark x1="44211" y1="4575" x2="44211" y2="4575"/>
                        <a14:backgroundMark x1="40000" y1="4575" x2="40000" y2="4575"/>
                        <a14:backgroundMark x1="37895" y1="3922" x2="37895" y2="3922"/>
                        <a14:backgroundMark x1="36842" y1="4575" x2="36842" y2="4575"/>
                        <a14:backgroundMark x1="34737" y1="4575" x2="34737" y2="4575"/>
                        <a14:backgroundMark x1="33684" y1="4575" x2="33684" y2="4575"/>
                        <a14:backgroundMark x1="41053" y1="4575" x2="41053" y2="4575"/>
                        <a14:backgroundMark x1="44211" y1="1961" x2="44211" y2="1961"/>
                        <a14:backgroundMark x1="53684" y1="3922" x2="53684" y2="3922"/>
                        <a14:backgroundMark x1="55789" y1="4575" x2="55789" y2="4575"/>
                        <a14:backgroundMark x1="57895" y1="4575" x2="57895" y2="4575"/>
                        <a14:backgroundMark x1="90526" y1="4575" x2="90526" y2="4575"/>
                        <a14:backgroundMark x1="96902" y1="74510" x2="96842" y2="76471"/>
                        <a14:backgroundMark x1="98947" y1="7190" x2="98864" y2="9929"/>
                        <a14:backgroundMark x1="86316" y1="4575" x2="86316" y2="4575"/>
                        <a14:backgroundMark x1="8421" y1="4575" x2="8421" y2="4575"/>
                        <a14:backgroundMark x1="6316" y1="4575" x2="6316" y2="4575"/>
                        <a14:backgroundMark x1="5263" y1="4575" x2="5263" y2="4575"/>
                        <a14:backgroundMark x1="10526" y1="3922" x2="10526" y2="3922"/>
                        <a14:backgroundMark x1="3158" y1="5229" x2="3158" y2="5229"/>
                        <a14:backgroundMark x1="13578" y1="91503" x2="15789" y2="93464"/>
                        <a14:backgroundMark x1="8421" y1="86928" x2="13578" y2="91503"/>
                        <a14:backgroundMark x1="20000" y1="94118" x2="20000" y2="94118"/>
                        <a14:backgroundMark x1="20000" y1="91503" x2="22105" y2="94118"/>
                        <a14:backgroundMark x1="10526" y1="86275" x2="10526" y2="86275"/>
                        <a14:backgroundMark x1="7368" y1="84967" x2="7368" y2="84967"/>
                        <a14:backgroundMark x1="8421" y1="84967" x2="8421" y2="84967"/>
                        <a14:backgroundMark x1="11579" y1="86928" x2="11579" y2="86928"/>
                        <a14:backgroundMark x1="24211" y1="92810" x2="24211" y2="92810"/>
                        <a14:backgroundMark x1="25263" y1="94771" x2="25263" y2="94771"/>
                        <a14:backgroundMark x1="81404" y1="90196" x2="72632" y2="96732"/>
                        <a14:backgroundMark x1="83158" y1="88889" x2="81404" y2="90196"/>
                        <a14:backgroundMark x1="85263" y1="88235" x2="85263" y2="88235"/>
                        <a14:backgroundMark x1="87368" y1="86928" x2="81053" y2="88889"/>
                        <a14:backgroundMark x1="72632" y1="97386" x2="66316" y2="99346"/>
                        <a14:backgroundMark x1="72632" y1="96732" x2="72632" y2="96732"/>
                        <a14:backgroundMark x1="71579" y1="96732" x2="71579" y2="96732"/>
                        <a14:backgroundMark x1="73684" y1="94771" x2="73684" y2="94771"/>
                        <a14:backgroundMark x1="66316" y1="99346" x2="29474" y2="99346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714387" y="1272239"/>
            <a:ext cx="748410" cy="120533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A61B828-87F1-8F4B-CCE9-7A5FEA14613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2823" b="79839" l="9709" r="89806">
                        <a14:foregroundMark x1="73786" y1="8065" x2="23786" y2="10081"/>
                        <a14:foregroundMark x1="48544" y1="2823" x2="48544" y2="10081"/>
                        <a14:foregroundMark x1="35922" y1="20161" x2="59223" y2="16129"/>
                        <a14:foregroundMark x1="59223" y1="45968" x2="39320" y2="47581"/>
                      </a14:backgroundRemoval>
                    </a14:imgEffect>
                  </a14:imgLayer>
                </a14:imgProps>
              </a:ext>
            </a:extLst>
          </a:blip>
          <a:srcRect b="11121"/>
          <a:stretch/>
        </p:blipFill>
        <p:spPr>
          <a:xfrm>
            <a:off x="6641629" y="1249815"/>
            <a:ext cx="1114482" cy="1423705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DCC66A00-D1E1-F850-BC47-7096362A34F7}"/>
              </a:ext>
            </a:extLst>
          </p:cNvPr>
          <p:cNvSpPr txBox="1"/>
          <p:nvPr/>
        </p:nvSpPr>
        <p:spPr>
          <a:xfrm>
            <a:off x="5288546" y="1505778"/>
            <a:ext cx="152477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=          &gt;</a:t>
            </a:r>
          </a:p>
        </p:txBody>
      </p:sp>
      <p:pic>
        <p:nvPicPr>
          <p:cNvPr id="22" name="Picture 20" descr="Human blood transfusion icon make an injection Vector Image">
            <a:extLst>
              <a:ext uri="{FF2B5EF4-FFF2-40B4-BE49-F238E27FC236}">
                <a16:creationId xmlns:a16="http://schemas.microsoft.com/office/drawing/2014/main" id="{5E49251E-0B89-77D7-04C7-6F2F3F42C5C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>
            <a:grayscl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ackgroundRemoval t="8981" b="85833" l="10000" r="90000">
                        <a14:foregroundMark x1="30500" y1="33241" x2="30500" y2="33241"/>
                        <a14:foregroundMark x1="48700" y1="85185" x2="48700" y2="85185"/>
                        <a14:foregroundMark x1="50500" y1="85833" x2="50500" y2="85833"/>
                        <a14:foregroundMark x1="74500" y1="26204" x2="74500" y2="26204"/>
                        <a14:foregroundMark x1="70700" y1="29722" x2="70700" y2="29722"/>
                        <a14:foregroundMark x1="65400" y1="24815" x2="84100" y2="38333"/>
                        <a14:foregroundMark x1="70000" y1="28519" x2="63700" y2="35000"/>
                        <a14:foregroundMark x1="63700" y1="35000" x2="63400" y2="35833"/>
                        <a14:foregroundMark x1="76300" y1="9167" x2="66400" y2="9352"/>
                        <a14:foregroundMark x1="79300" y1="25000" x2="68900" y2="30833"/>
                        <a14:foregroundMark x1="27500" y1="62500" x2="27500" y2="62500"/>
                        <a14:foregroundMark x1="23700" y1="60556" x2="36900" y2="65926"/>
                        <a14:foregroundMark x1="33800" y1="58241" x2="29500" y2="64074"/>
                        <a14:foregroundMark x1="70200" y1="48889" x2="70200" y2="48889"/>
                      </a14:backgroundRemoval>
                    </a14:imgEffect>
                    <a14:imgEffect>
                      <a14:artisticPhotocopy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9006"/>
          <a:stretch/>
        </p:blipFill>
        <p:spPr bwMode="auto">
          <a:xfrm>
            <a:off x="10207458" y="1795534"/>
            <a:ext cx="1398389" cy="13742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C30FC62F-54CF-683A-F111-92D8B23631F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ackgroundRemoval t="6618" b="96324" l="8081" r="89899">
                        <a14:foregroundMark x1="11111" y1="13235" x2="58586" y2="11765"/>
                        <a14:foregroundMark x1="58586" y1="11765" x2="81818" y2="13235"/>
                        <a14:foregroundMark x1="89723" y1="46324" x2="89899" y2="47059"/>
                        <a14:foregroundMark x1="81818" y1="13235" x2="89723" y2="46324"/>
                        <a14:foregroundMark x1="89731" y1="50000" x2="87879" y2="82353"/>
                        <a14:foregroundMark x1="89857" y1="47794" x2="89731" y2="50000"/>
                        <a14:foregroundMark x1="89899" y1="47059" x2="89857" y2="47794"/>
                        <a14:foregroundMark x1="87879" y1="82353" x2="69697" y2="93382"/>
                        <a14:foregroundMark x1="69697" y1="93382" x2="58944" y2="94403"/>
                        <a14:foregroundMark x1="25890" y1="88665" x2="30303" y2="66176"/>
                        <a14:foregroundMark x1="30303" y1="66176" x2="23232" y2="83824"/>
                        <a14:foregroundMark x1="23232" y1="83824" x2="11111" y2="69118"/>
                        <a14:foregroundMark x1="11111" y1="69118" x2="9326" y2="37500"/>
                        <a14:foregroundMark x1="10101" y1="14706" x2="16162" y2="12500"/>
                        <a14:foregroundMark x1="81818" y1="12500" x2="87879" y2="19118"/>
                        <a14:foregroundMark x1="70707" y1="91912" x2="58911" y2="94366"/>
                        <a14:foregroundMark x1="58952" y1="94412" x2="67677" y2="92647"/>
                        <a14:foregroundMark x1="78399" y1="50000" x2="79798" y2="56618"/>
                        <a14:foregroundMark x1="77933" y1="47794" x2="78399" y2="50000"/>
                        <a14:foregroundMark x1="77622" y1="46324" x2="77933" y2="47794"/>
                        <a14:foregroundMark x1="75758" y1="37500" x2="77622" y2="46324"/>
                        <a14:foregroundMark x1="79798" y1="56618" x2="57576" y2="68382"/>
                        <a14:foregroundMark x1="57576" y1="68382" x2="28283" y2="72059"/>
                        <a14:foregroundMark x1="28283" y1="72059" x2="22222" y2="54412"/>
                        <a14:foregroundMark x1="22222" y1="54412" x2="43434" y2="38235"/>
                        <a14:foregroundMark x1="43434" y1="38235" x2="71717" y2="50000"/>
                        <a14:foregroundMark x1="71717" y1="50000" x2="41414" y2="55147"/>
                        <a14:foregroundMark x1="41414" y1="55147" x2="23232" y2="44118"/>
                        <a14:foregroundMark x1="23232" y1="44118" x2="72727" y2="46324"/>
                        <a14:foregroundMark x1="72727" y1="46324" x2="72727" y2="47059"/>
                        <a14:foregroundMark x1="64646" y1="58824" x2="40404" y2="61029"/>
                        <a14:foregroundMark x1="40404" y1="61029" x2="63636" y2="58088"/>
                        <a14:foregroundMark x1="63636" y1="58088" x2="59596" y2="56618"/>
                        <a14:foregroundMark x1="56566" y1="53676" x2="26263" y2="55882"/>
                        <a14:foregroundMark x1="26263" y1="55882" x2="55556" y2="54412"/>
                        <a14:foregroundMark x1="55556" y1="54412" x2="76768" y2="55147"/>
                        <a14:foregroundMark x1="11111" y1="16912" x2="11111" y2="38971"/>
                        <a14:foregroundMark x1="86869" y1="20588" x2="86869" y2="42647"/>
                        <a14:foregroundMark x1="88889" y1="20588" x2="88889" y2="42647"/>
                        <a14:foregroundMark x1="88889" y1="47794" x2="88889" y2="49265"/>
                        <a14:foregroundMark x1="88889" y1="46324" x2="88889" y2="47794"/>
                        <a14:foregroundMark x1="10101" y1="19118" x2="9091" y2="15441"/>
                        <a14:foregroundMark x1="9091" y1="13971" x2="9091" y2="21324"/>
                        <a14:foregroundMark x1="67677" y1="11765" x2="58586" y2="12500"/>
                        <a14:foregroundMark x1="63636" y1="11765" x2="58586" y2="12500"/>
                        <a14:foregroundMark x1="65657" y1="11029" x2="59596" y2="11765"/>
                        <a14:foregroundMark x1="46465" y1="11029" x2="50505" y2="10294"/>
                        <a14:foregroundMark x1="49495" y1="6618" x2="49495" y2="6618"/>
                        <a14:backgroundMark x1="93939" y1="50000" x2="93939" y2="50000"/>
                        <a14:backgroundMark x1="71717" y1="98529" x2="71717" y2="98529"/>
                        <a14:backgroundMark x1="68687" y1="98529" x2="68687" y2="98529"/>
                        <a14:backgroundMark x1="66667" y1="97059" x2="66667" y2="97059"/>
                        <a14:backgroundMark x1="64646" y1="97059" x2="64646" y2="97059"/>
                        <a14:backgroundMark x1="62626" y1="98529" x2="30303" y2="99265"/>
                        <a14:backgroundMark x1="30303" y1="99265" x2="25253" y2="95588"/>
                        <a14:backgroundMark x1="92929" y1="47794" x2="92929" y2="47794"/>
                        <a14:backgroundMark x1="90909" y1="82353" x2="90909" y2="82353"/>
                        <a14:backgroundMark x1="67677" y1="8824" x2="67677" y2="8824"/>
                        <a14:backgroundMark x1="66667" y1="8824" x2="66667" y2="8824"/>
                        <a14:backgroundMark x1="65657" y1="8824" x2="65657" y2="8824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442762" y="1947115"/>
            <a:ext cx="568552" cy="853224"/>
          </a:xfrm>
          <a:prstGeom prst="rect">
            <a:avLst/>
          </a:prstGeom>
        </p:spPr>
      </p:pic>
      <p:sp>
        <p:nvSpPr>
          <p:cNvPr id="25" name="Arrow: Right 24">
            <a:extLst>
              <a:ext uri="{FF2B5EF4-FFF2-40B4-BE49-F238E27FC236}">
                <a16:creationId xmlns:a16="http://schemas.microsoft.com/office/drawing/2014/main" id="{B56DF530-91FE-26F8-BF74-38CDB44FC14D}"/>
              </a:ext>
            </a:extLst>
          </p:cNvPr>
          <p:cNvSpPr/>
          <p:nvPr/>
        </p:nvSpPr>
        <p:spPr>
          <a:xfrm>
            <a:off x="9533348" y="2080113"/>
            <a:ext cx="707976" cy="587229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pic>
        <p:nvPicPr>
          <p:cNvPr id="26" name="Picture 18" descr="Only Generic Allopathic Lyophilized Powder, Vee Excel Drugs And ...">
            <a:extLst>
              <a:ext uri="{FF2B5EF4-FFF2-40B4-BE49-F238E27FC236}">
                <a16:creationId xmlns:a16="http://schemas.microsoft.com/office/drawing/2014/main" id="{C01B8C45-B626-3F1D-C159-BF5351280F3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ackgroundRemoval t="5400" b="93600" l="9155" r="89789">
                        <a14:foregroundMark x1="39789" y1="6600" x2="39789" y2="6600"/>
                        <a14:foregroundMark x1="52817" y1="5600" x2="52817" y2="5600"/>
                        <a14:foregroundMark x1="40493" y1="26200" x2="40493" y2="26200"/>
                        <a14:foregroundMark x1="45423" y1="27800" x2="45423" y2="27800"/>
                        <a14:foregroundMark x1="71479" y1="25800" x2="72535" y2="49800"/>
                        <a14:foregroundMark x1="40493" y1="27600" x2="42958" y2="69600"/>
                        <a14:foregroundMark x1="61972" y1="26800" x2="60563" y2="49400"/>
                        <a14:foregroundMark x1="29930" y1="48000" x2="32746" y2="72400"/>
                        <a14:foregroundMark x1="25000" y1="40600" x2="20775" y2="67000"/>
                        <a14:foregroundMark x1="67958" y1="56200" x2="72535" y2="81000"/>
                        <a14:foregroundMark x1="82042" y1="92200" x2="30986" y2="93600"/>
                        <a14:foregroundMark x1="49296" y1="65200" x2="30986" y2="75600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57547" y="2321189"/>
            <a:ext cx="372086" cy="6550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4" descr="medical, liver, health, anatomy, organ ">
            <a:extLst>
              <a:ext uri="{FF2B5EF4-FFF2-40B4-BE49-F238E27FC236}">
                <a16:creationId xmlns:a16="http://schemas.microsoft.com/office/drawing/2014/main" id="{B0BE6111-D540-220C-71D3-B3883AB5DC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81877" y="3124374"/>
            <a:ext cx="696747" cy="6967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itle 3"/>
          <p:cNvSpPr txBox="1">
            <a:spLocks/>
          </p:cNvSpPr>
          <p:nvPr/>
        </p:nvSpPr>
        <p:spPr>
          <a:xfrm>
            <a:off x="129084" y="5656551"/>
            <a:ext cx="7081943" cy="828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475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>Zeineddin A et al. </a:t>
            </a:r>
            <a:r>
              <a:rPr lang="en-US" b="1" i="1" dirty="0"/>
              <a:t>Journal of Trauma and Acute Care Surgery</a:t>
            </a:r>
            <a:r>
              <a:rPr lang="en-US" b="1" dirty="0"/>
              <a:t>. </a:t>
            </a:r>
          </a:p>
          <a:p>
            <a:r>
              <a:rPr lang="en-US" b="1" dirty="0"/>
              <a:t>DOI: 10.1097/TA.0000000000004065</a:t>
            </a:r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127499" y="91440"/>
            <a:ext cx="11937003" cy="914400"/>
          </a:xfrm>
        </p:spPr>
        <p:txBody>
          <a:bodyPr>
            <a:normAutofit fontScale="90000"/>
          </a:bodyPr>
          <a:lstStyle/>
          <a:p>
            <a:pPr algn="ctr"/>
            <a:br>
              <a:rPr lang="en-US" sz="31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sz="31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2700" b="1" dirty="0">
                <a:effectLst/>
                <a:latin typeface="Calibri Light (headings)"/>
                <a:ea typeface="Calibri" panose="020F0502020204030204" pitchFamily="34" charset="0"/>
                <a:cs typeface="Calibri Light" panose="020F0302020204030204" pitchFamily="34" charset="0"/>
              </a:rPr>
              <a:t>Early Lyophilized Cryoprecipitate Enhances the ADAMTS13: VWF Ratio to Reduce Systemic Endotheliopathy and Lessen Lung Injury in a Mouse Polytrauma Hemorrhage Model</a:t>
            </a:r>
            <a:b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US" sz="44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667419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1D9A78"/>
      </a:accent1>
      <a:accent2>
        <a:srgbClr val="8BC145"/>
      </a:accent2>
      <a:accent3>
        <a:srgbClr val="36AFCE"/>
      </a:accent3>
      <a:accent4>
        <a:srgbClr val="1D6FA9"/>
      </a:accent4>
      <a:accent5>
        <a:srgbClr val="B74919"/>
      </a:accent5>
      <a:accent6>
        <a:srgbClr val="F19D19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8</TotalTime>
  <Words>164</Words>
  <Application>Microsoft Office PowerPoint</Application>
  <PresentationFormat>Widescreen</PresentationFormat>
  <Paragraphs>4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libri Light (headings)</vt:lpstr>
      <vt:lpstr>Office Theme</vt:lpstr>
      <vt:lpstr>  Early Lyophilized Cryoprecipitate Enhances the ADAMTS13: VWF Ratio to Reduce Systemic Endotheliopathy and Lessen Lung Injury in a Mouse Polytrauma Hemorrhage Model 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IMS</dc:title>
  <dc:creator>Jennifer Li</dc:creator>
  <cp:lastModifiedBy>Michelle Gaffney</cp:lastModifiedBy>
  <cp:revision>116</cp:revision>
  <dcterms:created xsi:type="dcterms:W3CDTF">2021-04-28T04:07:31Z</dcterms:created>
  <dcterms:modified xsi:type="dcterms:W3CDTF">2023-05-13T14:58:03Z</dcterms:modified>
</cp:coreProperties>
</file>